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248"/>
    <p:restoredTop sz="94658"/>
  </p:normalViewPr>
  <p:slideViewPr>
    <p:cSldViewPr snapToGrid="0">
      <p:cViewPr>
        <p:scale>
          <a:sx n="135" d="100"/>
          <a:sy n="135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71FE9-B652-A35C-3951-4919AF46C2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3C0796-8322-49E3-916D-EE3B00E7AC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0362BD-D8C3-8D4B-7C57-B398443F7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8E0E6-1FAF-13EF-E8E0-DE077900B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0C4B58-C7F0-3265-CDBA-2AB10A797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567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80BD90-9F52-ACFE-327F-E18A0F9FFE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8D218A-0524-03D4-804B-C4DD5AE35B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13E030-4C3F-17F8-9AFF-1BC4A091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8025A-86B7-AC3B-D1E2-BCC10A939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C980A-9F20-3CE6-178D-2269710B0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973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ACB4DE-E109-D4AE-1574-BAEB722D9F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BEBCFA-3B24-8DB9-BEB3-62884AADED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1A157-2AED-B1D4-395C-42A39E543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0C5C2-6DC8-2E2D-EE4C-4FA885A53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82BBB-3FAD-5F4E-A3A9-12379E0C2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42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2F2D48-D6C2-DC8B-70F7-557B1D4D07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4F26C-BA6D-4849-95CE-30B73C2942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8B7E0-9A0E-8260-97C4-20C3D32DC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2BE3EC-9C00-AD5C-DD4E-4F1259A8A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C8E2F-1F31-BA41-9884-D9154FEB0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436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DF634-FED2-7E90-71A6-58E9A89BA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4AA209-EC90-FD97-34CA-46567CAA5F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6B0583-298A-AF9A-01A2-189CD6D89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3AB6E6-EAAC-2EB8-905F-60BF5FE0D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4A0DEE-2087-E2D8-AAB8-4CBD5329C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647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FFB72-B152-5A9F-317E-A2E9BE12B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3D60AA-7D32-F0E3-34DC-9CF4048795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EEFB-436B-BB6B-77AF-31C0982D30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19D290-4AA1-C0F7-C46F-18438D3E3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BEB8F5-C62F-3E01-A96E-5E5FC02A5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E738DF-F641-FD6B-22CC-236ED0F7C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694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05517D-F512-92E4-D89D-FAFB68808E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1ED335-A270-D7C8-6D3E-A3ED11B36C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C43B5E-6186-39EA-BBD5-1223CBCB75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98FC56-B510-8B9E-EDD1-65987D79AA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28264E-7FD4-4564-3C97-026AA738B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1E1C90-0BCF-34B3-CDF3-0CB0E72FB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E31C8B-71B2-4369-FD6F-3C9ABFE30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8F5A92-DE2E-4558-2A8F-622F0EA9D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639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8AAA1-D13B-8093-EE0C-7A606C557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64C93D-DE27-E8AD-F3C8-E48D1A9F3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2F0F68-3227-D39B-E31D-2BC0BE82D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E4AB06-7342-4EB2-88ED-9C957A654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63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67961F-5B20-7D8E-5125-E5CA1BE2D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0A8760-EEEF-707D-443E-52396C663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6D4AE9-2B21-A99C-43AB-D39E33594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472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96548-9689-8433-83EC-0DB269631C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CC80A6-BE4E-B8CF-9323-4F99A11A56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EB16C4-4747-393F-171D-F092AA4FD6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2B157-01D2-4BB0-B387-BF74D0887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760A83-BAA2-C86D-B30C-EBBB68446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31B7AA-3E52-F9A0-22AC-57E915B63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6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E16B3-6BD1-C29D-5690-A95478B56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0770DF-A488-E780-FC14-DCB72F2EF4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8653F6-2425-5C2D-CA1B-AB028ACE3E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18EF5-93C3-3054-0E95-BA53C1CC3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ECF609-AEE1-8B53-AF98-17A1104E4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9822F1-D38C-F45E-B852-EC884B7AC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57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3A650-616A-2098-E28A-DB74C567A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B7DD8-9BF0-896B-F25A-DF0BEEB9F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0DAAB-6421-6AE1-A002-F4B7D7F0BB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E76FAC-6B0E-E442-B490-29DA59900F41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DD1B4-BA58-DBC9-23D1-551AFC373C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766F8-9630-C814-8671-782FE59725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EBF35C-99C2-734A-B4A7-A3205405D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223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C77F06-6F12-79D8-6518-50FEBD17712F}"/>
              </a:ext>
            </a:extLst>
          </p:cNvPr>
          <p:cNvSpPr txBox="1"/>
          <p:nvPr/>
        </p:nvSpPr>
        <p:spPr>
          <a:xfrm>
            <a:off x="1169894" y="531070"/>
            <a:ext cx="343981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 pitchFamily="2" charset="0"/>
              </a:rPr>
              <a:t>yH2AX 16.07.20</a:t>
            </a:r>
          </a:p>
          <a:p>
            <a:r>
              <a:rPr lang="en-US" sz="1400" dirty="0">
                <a:latin typeface="Helvetica" pitchFamily="2" charset="0"/>
              </a:rPr>
              <a:t>THZ531 500 nM</a:t>
            </a:r>
          </a:p>
          <a:p>
            <a:r>
              <a:rPr lang="en-US" sz="1400" dirty="0">
                <a:latin typeface="Helvetica" pitchFamily="2" charset="0"/>
              </a:rPr>
              <a:t>1-4: G7 - 0h, 6h, 24h, 48h </a:t>
            </a:r>
          </a:p>
          <a:p>
            <a:r>
              <a:rPr lang="en-US" sz="1400" dirty="0">
                <a:latin typeface="Helvetica" pitchFamily="2" charset="0"/>
              </a:rPr>
              <a:t>5-8: G144 - 0h, 6h, 24h, 48h </a:t>
            </a:r>
          </a:p>
          <a:p>
            <a:r>
              <a:rPr lang="en-US" sz="1400" dirty="0">
                <a:latin typeface="Helvetica" pitchFamily="2" charset="0"/>
              </a:rPr>
              <a:t>9-12: Hela - 0h, 6h, 24h, 48h </a:t>
            </a:r>
          </a:p>
          <a:p>
            <a:r>
              <a:rPr lang="en-US" sz="1400" dirty="0">
                <a:latin typeface="Helvetica" pitchFamily="2" charset="0"/>
              </a:rPr>
              <a:t>Control: 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</a:rPr>
              <a:t>GAPDH </a:t>
            </a:r>
            <a:endParaRPr lang="en-US" sz="1400" dirty="0">
              <a:latin typeface="Helvetica" pitchFamily="2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8C625DF-34EA-7A14-9293-D5811D00CF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9894" y="2100730"/>
            <a:ext cx="3949700" cy="2844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96928A-86CD-80E7-A82C-2808256018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1076" y="2227730"/>
            <a:ext cx="3479800" cy="2590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9DAB09D-B60B-3E61-FE8C-1BCBFFCF992E}"/>
              </a:ext>
            </a:extLst>
          </p:cNvPr>
          <p:cNvSpPr txBox="1"/>
          <p:nvPr/>
        </p:nvSpPr>
        <p:spPr>
          <a:xfrm>
            <a:off x="5344998" y="3384630"/>
            <a:ext cx="1322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200" dirty="0"/>
              <a:t>GAPDH: 36 kDa </a:t>
            </a:r>
            <a:r>
              <a:rPr lang="en-NO" sz="1200" b="1" dirty="0"/>
              <a:t>–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3C137A3-6FAE-881C-2150-3894E5290ACC}"/>
              </a:ext>
            </a:extLst>
          </p:cNvPr>
          <p:cNvSpPr txBox="1"/>
          <p:nvPr/>
        </p:nvSpPr>
        <p:spPr>
          <a:xfrm>
            <a:off x="5495828" y="4460856"/>
            <a:ext cx="1608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200" dirty="0"/>
              <a:t>yH2AX:15 kDa </a:t>
            </a:r>
            <a:r>
              <a:rPr lang="en-NO" sz="1200" b="1" dirty="0"/>
              <a:t>–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5841E9B-C6BF-37D6-1C29-AF79E53EC670}"/>
              </a:ext>
            </a:extLst>
          </p:cNvPr>
          <p:cNvSpPr/>
          <p:nvPr/>
        </p:nvSpPr>
        <p:spPr>
          <a:xfrm>
            <a:off x="6768445" y="4460856"/>
            <a:ext cx="1180897" cy="276999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05FB8FE-8CD4-2623-365F-2640879FE2FA}"/>
              </a:ext>
            </a:extLst>
          </p:cNvPr>
          <p:cNvSpPr/>
          <p:nvPr/>
        </p:nvSpPr>
        <p:spPr>
          <a:xfrm>
            <a:off x="7944523" y="4460856"/>
            <a:ext cx="944953" cy="276999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1C342A4-96AD-D437-3F37-0F9CD5163739}"/>
              </a:ext>
            </a:extLst>
          </p:cNvPr>
          <p:cNvSpPr/>
          <p:nvPr/>
        </p:nvSpPr>
        <p:spPr>
          <a:xfrm>
            <a:off x="8889476" y="4460856"/>
            <a:ext cx="1025248" cy="276999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093137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C7EBD8-72F9-F2B5-A459-BC02FE5D6AA5}"/>
              </a:ext>
            </a:extLst>
          </p:cNvPr>
          <p:cNvSpPr txBox="1"/>
          <p:nvPr/>
        </p:nvSpPr>
        <p:spPr>
          <a:xfrm>
            <a:off x="531832" y="181105"/>
            <a:ext cx="6098240" cy="15081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b="1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PARP G144 &amp; Hela 16.07.20</a:t>
            </a:r>
            <a:endParaRPr lang="en-US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G144: 1, 2, 3, 4; Hela: 5, 6, 7, 8.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Control RNAPII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latin typeface="Helvetica Neue" panose="02000503000000020004" pitchFamily="2" charset="0"/>
              </a:rPr>
              <a:t>THZ531 500 nM: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latin typeface="Helvetica Neue" panose="02000503000000020004" pitchFamily="2" charset="0"/>
              </a:rPr>
              <a:t>1&amp;5: DMSO -  2&amp;6: 6h -  3&amp;7: 24h – 4&amp;8: 48h</a:t>
            </a:r>
          </a:p>
          <a:p>
            <a:pPr>
              <a:buNone/>
            </a:pPr>
            <a:endParaRPr lang="en-US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04366AA-69C3-8A04-0907-36FA54CC79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489" y="1899024"/>
            <a:ext cx="3302000" cy="2844800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332C5FBE-71D4-130F-D198-0FE49A22C2F4}"/>
              </a:ext>
            </a:extLst>
          </p:cNvPr>
          <p:cNvGrpSpPr/>
          <p:nvPr/>
        </p:nvGrpSpPr>
        <p:grpSpPr>
          <a:xfrm>
            <a:off x="3883489" y="1899024"/>
            <a:ext cx="4487799" cy="3041276"/>
            <a:chOff x="3883489" y="1899024"/>
            <a:chExt cx="4487799" cy="304127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93346DF-8EDE-2150-16BC-68653C8901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75688" y="1917700"/>
              <a:ext cx="2895600" cy="3022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DE86E20-02D1-043B-4555-090B23B69E2C}"/>
                </a:ext>
              </a:extLst>
            </p:cNvPr>
            <p:cNvSpPr txBox="1"/>
            <p:nvPr/>
          </p:nvSpPr>
          <p:spPr>
            <a:xfrm>
              <a:off x="5800582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3C3EE4D-CEA9-22A4-6B48-1F8E556FC67E}"/>
                </a:ext>
              </a:extLst>
            </p:cNvPr>
            <p:cNvSpPr txBox="1"/>
            <p:nvPr/>
          </p:nvSpPr>
          <p:spPr>
            <a:xfrm>
              <a:off x="6083846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D512EA2-6481-22BD-3B8F-95F6BA65292A}"/>
                </a:ext>
              </a:extLst>
            </p:cNvPr>
            <p:cNvSpPr txBox="1"/>
            <p:nvPr/>
          </p:nvSpPr>
          <p:spPr>
            <a:xfrm>
              <a:off x="6367110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4071C2A-C97B-A427-7A82-E6EEA63F4B5F}"/>
                </a:ext>
              </a:extLst>
            </p:cNvPr>
            <p:cNvSpPr txBox="1"/>
            <p:nvPr/>
          </p:nvSpPr>
          <p:spPr>
            <a:xfrm>
              <a:off x="6650374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EFAEDD8-BA9E-19F5-C8C8-ABD5E98D0B24}"/>
                </a:ext>
              </a:extLst>
            </p:cNvPr>
            <p:cNvSpPr txBox="1"/>
            <p:nvPr/>
          </p:nvSpPr>
          <p:spPr>
            <a:xfrm>
              <a:off x="6933638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CC542EC-BD5F-619B-4026-F14811EAB8E0}"/>
                </a:ext>
              </a:extLst>
            </p:cNvPr>
            <p:cNvSpPr txBox="1"/>
            <p:nvPr/>
          </p:nvSpPr>
          <p:spPr>
            <a:xfrm>
              <a:off x="7216902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D626ADB-F986-3A90-77A1-DD25175E5E02}"/>
                </a:ext>
              </a:extLst>
            </p:cNvPr>
            <p:cNvSpPr txBox="1"/>
            <p:nvPr/>
          </p:nvSpPr>
          <p:spPr>
            <a:xfrm>
              <a:off x="7500166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9727FFE-6EC9-8CB2-5F72-6F18F50F74A2}"/>
                </a:ext>
              </a:extLst>
            </p:cNvPr>
            <p:cNvSpPr txBox="1"/>
            <p:nvPr/>
          </p:nvSpPr>
          <p:spPr>
            <a:xfrm>
              <a:off x="7783432" y="18990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400" dirty="0">
                  <a:latin typeface="Helvetica" pitchFamily="2" charset="0"/>
                </a:rPr>
                <a:t>8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9EAAD80-CC72-92F0-6218-5EC5FC6254B8}"/>
                </a:ext>
              </a:extLst>
            </p:cNvPr>
            <p:cNvSpPr/>
            <p:nvPr/>
          </p:nvSpPr>
          <p:spPr>
            <a:xfrm>
              <a:off x="5676121" y="3344103"/>
              <a:ext cx="1269914" cy="794264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4FC9AAB-1184-F18E-1BF6-D33581E1453C}"/>
                </a:ext>
              </a:extLst>
            </p:cNvPr>
            <p:cNvSpPr/>
            <p:nvPr/>
          </p:nvSpPr>
          <p:spPr>
            <a:xfrm>
              <a:off x="6946035" y="3344103"/>
              <a:ext cx="1269914" cy="794264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AB1DB5E-02D9-6628-9420-031ED7B6FAED}"/>
                </a:ext>
              </a:extLst>
            </p:cNvPr>
            <p:cNvSpPr txBox="1"/>
            <p:nvPr/>
          </p:nvSpPr>
          <p:spPr>
            <a:xfrm>
              <a:off x="3883489" y="3789275"/>
              <a:ext cx="1727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C</a:t>
              </a:r>
              <a:r>
                <a:rPr lang="en-NO" sz="1200" dirty="0"/>
                <a:t>leaved PARP 80 kDa </a:t>
              </a:r>
              <a:r>
                <a:rPr lang="en-NO" sz="1200" b="1" dirty="0"/>
                <a:t>–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86E5E2B-2BB6-BDF7-EFF0-D8268A9962A0}"/>
                </a:ext>
              </a:extLst>
            </p:cNvPr>
            <p:cNvSpPr txBox="1"/>
            <p:nvPr/>
          </p:nvSpPr>
          <p:spPr>
            <a:xfrm>
              <a:off x="4387369" y="3398031"/>
              <a:ext cx="153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O" sz="1200" dirty="0"/>
                <a:t>PARP 120 kDa </a:t>
              </a:r>
              <a:r>
                <a:rPr lang="en-NO" sz="1200" b="1" dirty="0"/>
                <a:t>–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58FC208C-D117-ED3C-0FB6-5FB290659CD0}"/>
              </a:ext>
            </a:extLst>
          </p:cNvPr>
          <p:cNvSpPr txBox="1"/>
          <p:nvPr/>
        </p:nvSpPr>
        <p:spPr>
          <a:xfrm>
            <a:off x="3883489" y="2572262"/>
            <a:ext cx="17681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200" dirty="0"/>
              <a:t>RNAPII (rpb1)220 kDa </a:t>
            </a:r>
            <a:r>
              <a:rPr lang="en-NO" sz="1200" b="1" dirty="0"/>
              <a:t>–</a:t>
            </a:r>
          </a:p>
        </p:txBody>
      </p:sp>
    </p:spTree>
    <p:extLst>
      <p:ext uri="{BB962C8B-B14F-4D97-AF65-F5344CB8AC3E}">
        <p14:creationId xmlns:p14="http://schemas.microsoft.com/office/powerpoint/2010/main" val="2629080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04DA982-A0B3-1321-9494-D281E33152C4}"/>
              </a:ext>
            </a:extLst>
          </p:cNvPr>
          <p:cNvSpPr txBox="1"/>
          <p:nvPr/>
        </p:nvSpPr>
        <p:spPr>
          <a:xfrm>
            <a:off x="198162" y="191555"/>
            <a:ext cx="6098240" cy="1231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b="1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PARP G7 30.04.20</a:t>
            </a:r>
            <a:endParaRPr lang="en-US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G7: all samples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latin typeface="Helvetica Neue" panose="02000503000000020004" pitchFamily="2" charset="0"/>
              </a:rPr>
              <a:t>Control: GAPDH 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latin typeface="Helvetica Neue" panose="02000503000000020004" pitchFamily="2" charset="0"/>
              </a:rPr>
              <a:t>THZ531 500 nM:</a:t>
            </a:r>
          </a:p>
          <a:p>
            <a:pPr>
              <a:buNone/>
            </a:pPr>
            <a:r>
              <a:rPr lang="en-US" sz="1400" dirty="0">
                <a:solidFill>
                  <a:srgbClr val="000000"/>
                </a:solidFill>
                <a:latin typeface="Helvetica Neue" panose="02000503000000020004" pitchFamily="2" charset="0"/>
              </a:rPr>
              <a:t>1: DMSO -  2: 6h -  3: 24h – 4: 48h</a:t>
            </a:r>
            <a:endParaRPr lang="en-US" sz="1400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009EEE4-87DE-CB73-6018-83E4556DC9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328" y="1925481"/>
            <a:ext cx="2820525" cy="243339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9D66625-920B-BD1C-E0C6-F8A4FA1111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4023" y="1549774"/>
            <a:ext cx="4330700" cy="3086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92C9F58-54D9-961E-BC47-6C4736088E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06005" y="1732145"/>
            <a:ext cx="4013200" cy="2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ED6E6CA-E391-15FC-38F0-F05BA7474EC9}"/>
              </a:ext>
            </a:extLst>
          </p:cNvPr>
          <p:cNvSpPr txBox="1"/>
          <p:nvPr/>
        </p:nvSpPr>
        <p:spPr>
          <a:xfrm>
            <a:off x="4017731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E7D522-DCBE-BD1E-F89D-2F521D241892}"/>
              </a:ext>
            </a:extLst>
          </p:cNvPr>
          <p:cNvSpPr txBox="1"/>
          <p:nvPr/>
        </p:nvSpPr>
        <p:spPr>
          <a:xfrm>
            <a:off x="4406076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DF0FC2-A5FE-B332-786F-214257536558}"/>
              </a:ext>
            </a:extLst>
          </p:cNvPr>
          <p:cNvSpPr txBox="1"/>
          <p:nvPr/>
        </p:nvSpPr>
        <p:spPr>
          <a:xfrm>
            <a:off x="4794421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891956-1AEE-E2B0-B3AD-2AB52512FFCE}"/>
              </a:ext>
            </a:extLst>
          </p:cNvPr>
          <p:cNvSpPr txBox="1"/>
          <p:nvPr/>
        </p:nvSpPr>
        <p:spPr>
          <a:xfrm>
            <a:off x="5182767" y="18613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8374D49-17C3-FA01-3FC3-7BA83D142291}"/>
              </a:ext>
            </a:extLst>
          </p:cNvPr>
          <p:cNvSpPr txBox="1"/>
          <p:nvPr/>
        </p:nvSpPr>
        <p:spPr>
          <a:xfrm>
            <a:off x="5897397" y="186555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BF4527E-DC92-E3E3-8036-E8DAC5820870}"/>
              </a:ext>
            </a:extLst>
          </p:cNvPr>
          <p:cNvSpPr txBox="1"/>
          <p:nvPr/>
        </p:nvSpPr>
        <p:spPr>
          <a:xfrm>
            <a:off x="6296402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DF9546-CF9C-E8E2-8944-C91BB5EAC85E}"/>
              </a:ext>
            </a:extLst>
          </p:cNvPr>
          <p:cNvSpPr txBox="1"/>
          <p:nvPr/>
        </p:nvSpPr>
        <p:spPr>
          <a:xfrm>
            <a:off x="6695407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BC45E9F-C41D-0BDB-71D0-265F47E6185B}"/>
              </a:ext>
            </a:extLst>
          </p:cNvPr>
          <p:cNvSpPr txBox="1"/>
          <p:nvPr/>
        </p:nvSpPr>
        <p:spPr>
          <a:xfrm>
            <a:off x="7094413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50C95F0-770D-CA13-CA71-4F2A19C812FE}"/>
              </a:ext>
            </a:extLst>
          </p:cNvPr>
          <p:cNvSpPr txBox="1"/>
          <p:nvPr/>
        </p:nvSpPr>
        <p:spPr>
          <a:xfrm>
            <a:off x="8206405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578DAB8-D399-9B2F-06BC-3DA299F0B06E}"/>
              </a:ext>
            </a:extLst>
          </p:cNvPr>
          <p:cNvSpPr txBox="1"/>
          <p:nvPr/>
        </p:nvSpPr>
        <p:spPr>
          <a:xfrm>
            <a:off x="8594750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4CC7C1-4CE6-BD08-868F-5F8F9E6EAC0B}"/>
              </a:ext>
            </a:extLst>
          </p:cNvPr>
          <p:cNvSpPr txBox="1"/>
          <p:nvPr/>
        </p:nvSpPr>
        <p:spPr>
          <a:xfrm>
            <a:off x="8983095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014436-D0D6-9631-F30A-AF4836CB0DDE}"/>
              </a:ext>
            </a:extLst>
          </p:cNvPr>
          <p:cNvSpPr txBox="1"/>
          <p:nvPr/>
        </p:nvSpPr>
        <p:spPr>
          <a:xfrm>
            <a:off x="9371441" y="18613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D6351C7-9630-4F2B-6D09-6B4FC5665AA4}"/>
              </a:ext>
            </a:extLst>
          </p:cNvPr>
          <p:cNvSpPr txBox="1"/>
          <p:nvPr/>
        </p:nvSpPr>
        <p:spPr>
          <a:xfrm>
            <a:off x="10086071" y="186555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D8E1CDA-F896-CA91-24CC-EC38D52CBEE5}"/>
              </a:ext>
            </a:extLst>
          </p:cNvPr>
          <p:cNvSpPr txBox="1"/>
          <p:nvPr/>
        </p:nvSpPr>
        <p:spPr>
          <a:xfrm>
            <a:off x="10485076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4E677C-9D0D-CA3C-3A1C-D4E417959D54}"/>
              </a:ext>
            </a:extLst>
          </p:cNvPr>
          <p:cNvSpPr txBox="1"/>
          <p:nvPr/>
        </p:nvSpPr>
        <p:spPr>
          <a:xfrm>
            <a:off x="10884081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3A42244-1064-AA15-9F5D-A634E17CDA83}"/>
              </a:ext>
            </a:extLst>
          </p:cNvPr>
          <p:cNvSpPr txBox="1"/>
          <p:nvPr/>
        </p:nvSpPr>
        <p:spPr>
          <a:xfrm>
            <a:off x="11283087" y="18613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400" dirty="0">
                <a:latin typeface="Helvetica" pitchFamily="2" charset="0"/>
              </a:rPr>
              <a:t>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E89937-8A6E-D0EB-3A7B-8E72B5B12B13}"/>
              </a:ext>
            </a:extLst>
          </p:cNvPr>
          <p:cNvSpPr txBox="1"/>
          <p:nvPr/>
        </p:nvSpPr>
        <p:spPr>
          <a:xfrm>
            <a:off x="2894403" y="4358875"/>
            <a:ext cx="7455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200" dirty="0"/>
              <a:t>36 kDa </a:t>
            </a:r>
            <a:r>
              <a:rPr lang="en-NO" sz="1200" b="1" dirty="0"/>
              <a:t>–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AF0F07-D7B2-605C-EE45-73DECECF42A3}"/>
              </a:ext>
            </a:extLst>
          </p:cNvPr>
          <p:cNvSpPr txBox="1"/>
          <p:nvPr/>
        </p:nvSpPr>
        <p:spPr>
          <a:xfrm>
            <a:off x="2894403" y="2538826"/>
            <a:ext cx="7455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200" dirty="0"/>
              <a:t>80 kDa </a:t>
            </a:r>
            <a:r>
              <a:rPr lang="en-NO" sz="1200" b="1" dirty="0"/>
              <a:t>–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652BE29-F5A8-BF71-7DEF-8EEF6A0169E4}"/>
              </a:ext>
            </a:extLst>
          </p:cNvPr>
          <p:cNvSpPr txBox="1"/>
          <p:nvPr/>
        </p:nvSpPr>
        <p:spPr>
          <a:xfrm>
            <a:off x="2817846" y="2093654"/>
            <a:ext cx="827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200" dirty="0"/>
              <a:t>120 kDa </a:t>
            </a:r>
            <a:r>
              <a:rPr lang="en-NO" sz="1200" b="1" dirty="0"/>
              <a:t>–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C4B972C-F154-18CD-D22B-67095871EDD0}"/>
              </a:ext>
            </a:extLst>
          </p:cNvPr>
          <p:cNvSpPr txBox="1"/>
          <p:nvPr/>
        </p:nvSpPr>
        <p:spPr>
          <a:xfrm>
            <a:off x="11446411" y="2538826"/>
            <a:ext cx="7455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200" b="1" dirty="0"/>
              <a:t>– </a:t>
            </a:r>
            <a:r>
              <a:rPr lang="en-NO" sz="1200" dirty="0"/>
              <a:t>80 kDa</a:t>
            </a:r>
            <a:endParaRPr lang="en-NO" sz="12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FA3B7E-23FC-39E2-40F3-4D4A1926A6F5}"/>
              </a:ext>
            </a:extLst>
          </p:cNvPr>
          <p:cNvSpPr txBox="1"/>
          <p:nvPr/>
        </p:nvSpPr>
        <p:spPr>
          <a:xfrm>
            <a:off x="11464655" y="2117057"/>
            <a:ext cx="827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sz="1200" b="1" dirty="0"/>
              <a:t>– </a:t>
            </a:r>
            <a:r>
              <a:rPr lang="en-NO" sz="1200" dirty="0"/>
              <a:t>120 kDa</a:t>
            </a:r>
            <a:endParaRPr lang="en-NO" sz="1200" b="1" dirty="0"/>
          </a:p>
        </p:txBody>
      </p:sp>
    </p:spTree>
    <p:extLst>
      <p:ext uri="{BB962C8B-B14F-4D97-AF65-F5344CB8AC3E}">
        <p14:creationId xmlns:p14="http://schemas.microsoft.com/office/powerpoint/2010/main" val="3864988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180</Words>
  <Application>Microsoft Macintosh PowerPoint</Application>
  <PresentationFormat>Widescreen</PresentationFormat>
  <Paragraphs>5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Helvetica</vt:lpstr>
      <vt:lpstr>Helvetica Neue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o Prakash Pandey</dc:creator>
  <cp:lastModifiedBy>Sara Bachmann Markusson</cp:lastModifiedBy>
  <cp:revision>2</cp:revision>
  <dcterms:created xsi:type="dcterms:W3CDTF">2025-12-12T10:37:58Z</dcterms:created>
  <dcterms:modified xsi:type="dcterms:W3CDTF">2025-12-12T12:45:32Z</dcterms:modified>
</cp:coreProperties>
</file>